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98841" autoAdjust="0"/>
  </p:normalViewPr>
  <p:slideViewPr>
    <p:cSldViewPr>
      <p:cViewPr>
        <p:scale>
          <a:sx n="70" d="100"/>
          <a:sy n="70" d="100"/>
        </p:scale>
        <p:origin x="-4152" y="-64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>
                <a:latin typeface="Arial"/>
              </a:defRPr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>
                <a:latin typeface="Arial"/>
              </a:defRPr>
            </a:lvl1pPr>
          </a:lstStyle>
          <a:p>
            <a:fld id="{08F86693-44F4-4FAD-B78A-E8C66BE53ABB}" type="datetimeFigureOut">
              <a:rPr lang="en-US" smtClean="0"/>
              <a:pPr/>
              <a:t>6/28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>
                <a:latin typeface="Arial"/>
              </a:defRPr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>
                <a:latin typeface="Arial"/>
              </a:defRPr>
            </a:lvl1pPr>
          </a:lstStyle>
          <a:p>
            <a:fld id="{65CFE1ED-8EB7-46C9-B03C-F99F283BBAF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7663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Arial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Arial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Arial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Arial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Arial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80F50E-CCC8-4133-B15A-8FEBCFB36FD2}" type="datetimeFigureOut">
              <a:rPr lang="en-US" smtClean="0"/>
              <a:t>6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E4891B-29EB-4B56-A22D-0194509BCA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38361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80F50E-CCC8-4133-B15A-8FEBCFB36FD2}" type="datetimeFigureOut">
              <a:rPr lang="en-US" smtClean="0"/>
              <a:t>6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E4891B-29EB-4B56-A22D-0194509BCA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52203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80F50E-CCC8-4133-B15A-8FEBCFB36FD2}" type="datetimeFigureOut">
              <a:rPr lang="en-US" smtClean="0"/>
              <a:t>6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E4891B-29EB-4B56-A22D-0194509BCA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74527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80F50E-CCC8-4133-B15A-8FEBCFB36FD2}" type="datetimeFigureOut">
              <a:rPr lang="en-US" smtClean="0"/>
              <a:t>6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E4891B-29EB-4B56-A22D-0194509BCA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48613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80F50E-CCC8-4133-B15A-8FEBCFB36FD2}" type="datetimeFigureOut">
              <a:rPr lang="en-US" smtClean="0"/>
              <a:t>6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E4891B-29EB-4B56-A22D-0194509BCA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19250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80F50E-CCC8-4133-B15A-8FEBCFB36FD2}" type="datetimeFigureOut">
              <a:rPr lang="en-US" smtClean="0"/>
              <a:t>6/2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E4891B-29EB-4B56-A22D-0194509BCA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6266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80F50E-CCC8-4133-B15A-8FEBCFB36FD2}" type="datetimeFigureOut">
              <a:rPr lang="en-US" smtClean="0"/>
              <a:t>6/28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E4891B-29EB-4B56-A22D-0194509BCA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37766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80F50E-CCC8-4133-B15A-8FEBCFB36FD2}" type="datetimeFigureOut">
              <a:rPr lang="en-US" smtClean="0"/>
              <a:t>6/28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E4891B-29EB-4B56-A22D-0194509BCA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84840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80F50E-CCC8-4133-B15A-8FEBCFB36FD2}" type="datetimeFigureOut">
              <a:rPr lang="en-US" smtClean="0"/>
              <a:t>6/28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E4891B-29EB-4B56-A22D-0194509BCA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37251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80F50E-CCC8-4133-B15A-8FEBCFB36FD2}" type="datetimeFigureOut">
              <a:rPr lang="en-US" smtClean="0"/>
              <a:t>6/2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E4891B-29EB-4B56-A22D-0194509BCA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90946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80F50E-CCC8-4133-B15A-8FEBCFB36FD2}" type="datetimeFigureOut">
              <a:rPr lang="en-US" smtClean="0"/>
              <a:t>6/2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E4891B-29EB-4B56-A22D-0194509BCA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13590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  <a:latin typeface="Arial"/>
              </a:defRPr>
            </a:lvl1pPr>
          </a:lstStyle>
          <a:p>
            <a:fld id="{B780F50E-CCC8-4133-B15A-8FEBCFB36FD2}" type="datetimeFigureOut">
              <a:rPr lang="en-US" smtClean="0"/>
              <a:pPr/>
              <a:t>6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  <a:latin typeface="Arial"/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  <a:latin typeface="Arial"/>
              </a:defRPr>
            </a:lvl1pPr>
          </a:lstStyle>
          <a:p>
            <a:fld id="{3AE4891B-29EB-4B56-A22D-0194509BCA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65471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Arial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Arial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Arial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Arial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Arial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Arial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124744" y="8172400"/>
            <a:ext cx="468052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 smtClean="0">
                <a:latin typeface="Arial"/>
              </a:rPr>
              <a:t>Figure S3. </a:t>
            </a:r>
            <a:r>
              <a:rPr lang="en-US" sz="1000" b="1" dirty="0">
                <a:solidFill>
                  <a:srgbClr val="00000A"/>
                </a:solidFill>
                <a:latin typeface="Arial"/>
                <a:ea typeface="Droid Sans Fallback"/>
                <a:cs typeface="Arial"/>
              </a:rPr>
              <a:t>Differences in gene expression for known splicing (a) and editing (b) factors after 3 and 12 h of heat stress</a:t>
            </a:r>
            <a:r>
              <a:rPr lang="en-US" sz="1000" dirty="0" smtClean="0">
                <a:solidFill>
                  <a:srgbClr val="00000A"/>
                </a:solidFill>
                <a:effectLst/>
                <a:latin typeface="Arial"/>
                <a:ea typeface="Droid Sans Fallback"/>
                <a:cs typeface="Arial"/>
              </a:rPr>
              <a:t>. </a:t>
            </a:r>
          </a:p>
          <a:p>
            <a:pPr algn="just"/>
            <a:r>
              <a:rPr lang="en-US" sz="1000" dirty="0" smtClean="0">
                <a:solidFill>
                  <a:srgbClr val="00000A"/>
                </a:solidFill>
                <a:effectLst/>
                <a:latin typeface="Arial"/>
                <a:ea typeface="Droid Sans Fallback"/>
                <a:cs typeface="Arial"/>
              </a:rPr>
              <a:t>The </a:t>
            </a:r>
            <a:r>
              <a:rPr lang="en-US" sz="1000" dirty="0">
                <a:solidFill>
                  <a:srgbClr val="00000A"/>
                </a:solidFill>
                <a:effectLst/>
                <a:latin typeface="Arial"/>
                <a:ea typeface="Droid Sans Fallback"/>
                <a:cs typeface="Arial"/>
              </a:rPr>
              <a:t>horizontal dashed lines represent a two-fold change from control conditions.</a:t>
            </a:r>
            <a:r>
              <a:rPr lang="en-US" sz="1000" dirty="0">
                <a:effectLst/>
                <a:latin typeface="Arial"/>
                <a:cs typeface="Arial"/>
              </a:rPr>
              <a:t> </a:t>
            </a:r>
            <a:endParaRPr lang="en-US" sz="1000" dirty="0">
              <a:latin typeface="Arial"/>
            </a:endParaRP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5011" y="971600"/>
            <a:ext cx="5627979" cy="64442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2637986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12700">
          <a:solidFill>
            <a:schemeClr val="tx1"/>
          </a:solidFill>
        </a:ln>
        <a:effectLst/>
      </a:spPr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0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noît</dc:creator>
  <cp:lastModifiedBy>Benoît</cp:lastModifiedBy>
  <cp:revision>30</cp:revision>
  <cp:lastPrinted>2015-10-30T18:40:55Z</cp:lastPrinted>
  <dcterms:created xsi:type="dcterms:W3CDTF">2015-10-01T14:24:23Z</dcterms:created>
  <dcterms:modified xsi:type="dcterms:W3CDTF">2016-06-28T19:41:18Z</dcterms:modified>
</cp:coreProperties>
</file>